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45"/>
  </p:normalViewPr>
  <p:slideViewPr>
    <p:cSldViewPr snapToGrid="0">
      <p:cViewPr varScale="1">
        <p:scale>
          <a:sx n="109" d="100"/>
          <a:sy n="109" d="100"/>
        </p:scale>
        <p:origin x="6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7F3D70-BA93-C6CA-ADFA-440BBE6BAE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A0AD5C-B7E1-09F2-BB2F-B564E0FF93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2F98E-D723-4F91-917A-F4D119927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B5F97-1AFF-81A6-A5A8-A9848C1A2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EA104-A9B3-1F62-F224-A7CAFB6A8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532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82968-DF0B-6B2A-1112-9CBC803B7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DA7678-F639-5BA9-8EE8-C8574CD5E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F164EE-7BCB-87EB-994B-479EAC3B3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90345-6613-5936-7454-9B19465FE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41D4B6-A270-D36D-A261-4E11C3C0E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051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2C67EF-AE25-5739-E132-A77F32670E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46B8E6-BAA6-4CAD-012D-A6FCC53208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F2909F-CC5A-D10C-9B44-B9A896F55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89C66F-91E7-3D00-8EDB-A00A0A866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3FC68B-1F31-669A-CED7-E1B4C9169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772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710A9-F714-1067-01A3-A3F23C6E5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5442C-F48C-A26E-FCD5-63906159B8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EBBA00-4161-DF64-A30E-2C545201D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F7384F-713B-2F07-ACC8-5843AB57A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94B06E-78F4-D8F6-3724-2DFC60E9F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50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27EBC3-C2E3-4A1D-30EC-4A43ADA62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0D91CF-6ECB-0CF6-3526-B8152351BE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190F1-D92D-8079-0D96-65739FE85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42D1A-4E0A-1FFA-299D-D0E050E54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8EE493-E70C-104A-3E32-DB847C1A6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663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D67A5B-2171-FBD1-59E0-3E058B766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584522-515A-67F4-4D6B-33C8EB8F13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47C01B-A918-F96C-38A0-EF229A61A8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DAD4CA-E6FE-829A-C1B2-86566BC7A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506418-E119-54D0-4AD3-492EBF571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524144-773B-8F7A-7C68-6A491F2D2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516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813DF-EE69-1A81-29BB-0052C3953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738CD6-D7BF-04E9-A4C3-5A3E49B4B1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9D6FA1-C693-34E4-984C-7E838B8A1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A43B90-6205-0D74-CB9F-F20775B517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ED68F5-7130-9C51-9243-ABBF32BB3D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A39516-BC43-4161-EB75-6FBEFDAFB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4E6FB0-A7B8-8500-C66E-4F06E9E5C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4711F8-4F38-DFA2-0988-50FF0AAA5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921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B6A9F0-BFBB-40CD-64F4-C1DAEFE6D5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158633-496E-1987-AEDE-09A01DB91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A132A0-5A3C-C3D8-6A89-B384D61A6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C5E459-DB2F-B36A-24BF-DF2A7A369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551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6E38FB-815B-45CD-C621-2CF105701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B3F46A-C73C-F26D-A367-90F9D71BB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C49857-593B-7739-8474-7AD77CD7F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96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BECCB-A9C6-658A-E961-82C5B8E16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934A92-6358-C7B2-EBA6-34D05CCD20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71BE33-AFB4-0EFF-DD75-190165B82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243205-5B90-283F-56FA-3CF094A49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337B1A-8E32-3864-780B-D11A3545B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E92408-39C9-E513-4E96-F09BF77F1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863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F2034-D4C3-4A25-47D8-87DF43882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920D074-99C7-7591-AB9E-9F9CF81E08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9D3307-1FA5-6C04-1D2C-775DBE5A98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4567F8-5ACD-8E4E-34DD-EB15B89DC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D7633D-0D78-008A-0E2A-CABB82A2C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8CD68E-BAA4-1628-2DB1-27C9E3588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47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5F2CFC-A170-F818-2452-EE5FAFB7F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730ADA-ED0D-7424-00BA-2C1AEF12E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C4ACED-8C15-EB66-BE3C-1F568508BB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EAC77D-2B37-3540-B96A-49772ABE494A}" type="datetimeFigureOut">
              <a:rPr lang="en-US" smtClean="0"/>
              <a:t>5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D5E86A-F0FD-4C42-154A-3FE49967F7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E6C280-BE94-6375-2C54-C73305BFE0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B1454A-893D-EE48-B1F4-F129B38543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240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1_63x_zoom2_A2_500nM_TL100">
            <a:hlinkClick r:id="" action="ppaction://media"/>
            <a:extLst>
              <a:ext uri="{FF2B5EF4-FFF2-40B4-BE49-F238E27FC236}">
                <a16:creationId xmlns:a16="http://schemas.microsoft.com/office/drawing/2014/main" id="{1D97F1EC-9382-C2C1-F7B1-15C64D6B112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contrast="-20000"/>
          </a:blip>
          <a:stretch>
            <a:fillRect/>
          </a:stretch>
        </p:blipFill>
        <p:spPr>
          <a:xfrm>
            <a:off x="2810308" y="234951"/>
            <a:ext cx="4982873" cy="49828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A06AC54-AFD1-FE6E-D5C1-0E0C8A32F6CD}"/>
              </a:ext>
            </a:extLst>
          </p:cNvPr>
          <p:cNvSpPr txBox="1"/>
          <p:nvPr/>
        </p:nvSpPr>
        <p:spPr>
          <a:xfrm>
            <a:off x="654628" y="5320145"/>
            <a:ext cx="96012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0" u="none" strike="noStrike" dirty="0">
                <a:solidFill>
                  <a:srgbClr val="000000"/>
                </a:solidFill>
                <a:effectLst/>
              </a:rPr>
              <a:t>Video S1.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 Time-lapse confocal imaging of a HEK293T cell treated for 24 hours with 500 </a:t>
            </a:r>
            <a:r>
              <a:rPr lang="en-US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nM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en-US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DyLight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™ 633-labeled DTCCL8. Imaging was performed using a Zeiss LSM 700 confocal microscope with a 63× oil immersion objective and 2× digital zoom. Images were acquired at 7 frames per second over a total duration of ~14.3 seconds. The fluorescence signal (</a:t>
            </a:r>
            <a:r>
              <a:rPr lang="en-US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DyLight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633) indicates DTCCL8 localization and uptak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23165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5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-webkit-standard</vt:lpstr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iaris, Hippokratis</dc:creator>
  <cp:lastModifiedBy>Kiaris, Hippokratis</cp:lastModifiedBy>
  <cp:revision>1</cp:revision>
  <dcterms:created xsi:type="dcterms:W3CDTF">2025-05-03T17:57:09Z</dcterms:created>
  <dcterms:modified xsi:type="dcterms:W3CDTF">2025-05-03T17:59:09Z</dcterms:modified>
</cp:coreProperties>
</file>